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66" d="100"/>
          <a:sy n="66" d="100"/>
        </p:scale>
        <p:origin x="3276" y="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18/11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813088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18/11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633193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18/11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78603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18/11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881112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18/11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74483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18/11/20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00553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18/11/2020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296009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18/11/2020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917359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18/11/2020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526443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18/11/20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939296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18/11/20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895778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89E74B-E96B-4798-98E1-9D2C6993865E}" type="datetimeFigureOut">
              <a:rPr lang="en-AU" smtClean="0"/>
              <a:t>18/11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781629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Text Box 2"/>
          <p:cNvSpPr txBox="1">
            <a:spLocks noChangeArrowheads="1"/>
          </p:cNvSpPr>
          <p:nvPr/>
        </p:nvSpPr>
        <p:spPr bwMode="auto">
          <a:xfrm>
            <a:off x="593407" y="1674495"/>
            <a:ext cx="301622" cy="381633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MY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en-AU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3" name="Text Box 2"/>
          <p:cNvSpPr txBox="1">
            <a:spLocks noChangeArrowheads="1"/>
          </p:cNvSpPr>
          <p:nvPr/>
        </p:nvSpPr>
        <p:spPr bwMode="auto">
          <a:xfrm>
            <a:off x="3278706" y="1674495"/>
            <a:ext cx="301622" cy="381633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800" b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en-AU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4" name="Text Box 2"/>
          <p:cNvSpPr txBox="1">
            <a:spLocks noChangeArrowheads="1"/>
          </p:cNvSpPr>
          <p:nvPr/>
        </p:nvSpPr>
        <p:spPr bwMode="auto">
          <a:xfrm>
            <a:off x="593407" y="3971713"/>
            <a:ext cx="301622" cy="381633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endParaRPr lang="en-AU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5" name="Text Box 2"/>
          <p:cNvSpPr txBox="1">
            <a:spLocks noChangeArrowheads="1"/>
          </p:cNvSpPr>
          <p:nvPr/>
        </p:nvSpPr>
        <p:spPr bwMode="auto">
          <a:xfrm>
            <a:off x="3278706" y="3971713"/>
            <a:ext cx="301622" cy="381633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endParaRPr lang="en-AU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6" name="Text Box 2"/>
          <p:cNvSpPr txBox="1">
            <a:spLocks noChangeArrowheads="1"/>
          </p:cNvSpPr>
          <p:nvPr/>
        </p:nvSpPr>
        <p:spPr bwMode="auto">
          <a:xfrm>
            <a:off x="593407" y="6268931"/>
            <a:ext cx="301622" cy="381633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endParaRPr lang="en-AU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7" name="Text Box 2"/>
          <p:cNvSpPr txBox="1">
            <a:spLocks noChangeArrowheads="1"/>
          </p:cNvSpPr>
          <p:nvPr/>
        </p:nvSpPr>
        <p:spPr bwMode="auto">
          <a:xfrm>
            <a:off x="3278706" y="6268931"/>
            <a:ext cx="301622" cy="381633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</a:t>
            </a:r>
            <a:endParaRPr lang="en-AU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8" name="Text Box 2"/>
          <p:cNvSpPr txBox="1">
            <a:spLocks noChangeArrowheads="1"/>
          </p:cNvSpPr>
          <p:nvPr/>
        </p:nvSpPr>
        <p:spPr bwMode="auto">
          <a:xfrm>
            <a:off x="593407" y="8566149"/>
            <a:ext cx="301622" cy="381633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endParaRPr lang="en-AU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4" name="Text Box 2"/>
          <p:cNvSpPr txBox="1">
            <a:spLocks noChangeArrowheads="1"/>
          </p:cNvSpPr>
          <p:nvPr/>
        </p:nvSpPr>
        <p:spPr bwMode="auto">
          <a:xfrm>
            <a:off x="3378314" y="8686751"/>
            <a:ext cx="2630600" cy="2221381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AU" sz="1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7:</a:t>
            </a:r>
            <a:r>
              <a:rPr lang="en-AU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bundance estimation values in transcript-per-million (TPM) for contigs in the 5 analysed shrimp species that matched with shrimp allergens. </a:t>
            </a:r>
            <a:r>
              <a:rPr lang="en-AU" sz="1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AU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tropomyosin, </a:t>
            </a:r>
            <a:r>
              <a:rPr lang="en-AU" sz="1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AU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arginine kinase, </a:t>
            </a:r>
            <a:r>
              <a:rPr lang="en-AU" sz="1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AU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myosin light chain, </a:t>
            </a:r>
            <a:r>
              <a:rPr lang="en-AU" sz="1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AU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sarcoplasmic calcium-binding protein, </a:t>
            </a:r>
            <a:r>
              <a:rPr lang="en-AU" sz="1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AU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troponin C, </a:t>
            </a:r>
            <a:r>
              <a:rPr lang="en-AU" sz="1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</a:t>
            </a:r>
            <a:r>
              <a:rPr lang="en-AU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troponin I, and </a:t>
            </a:r>
            <a:r>
              <a:rPr lang="en-AU" sz="1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AU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AU" sz="10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riosephophate</a:t>
            </a:r>
            <a:r>
              <a:rPr lang="en-AU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isomerase. </a:t>
            </a:r>
            <a:r>
              <a:rPr lang="en-AU" sz="10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-test </a:t>
            </a:r>
            <a:r>
              <a:rPr lang="en-AU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as employed to measure the significance of difference between two contigs from the same species, if present (*: P ≤ 0.05, **: P ≤ 0.01, ***: P ≤ 0.001, ****: P ≤ 0.0001)</a:t>
            </a:r>
            <a:endParaRPr lang="en-AU" sz="1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990" t="17457"/>
          <a:stretch/>
        </p:blipFill>
        <p:spPr>
          <a:xfrm>
            <a:off x="895029" y="1745967"/>
            <a:ext cx="2216192" cy="2236418"/>
          </a:xfrm>
          <a:prstGeom prst="rect">
            <a:avLst/>
          </a:prstGeom>
        </p:spPr>
      </p:pic>
      <p:pic>
        <p:nvPicPr>
          <p:cNvPr id="39" name="Picture 3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80328" y="1747604"/>
            <a:ext cx="2164732" cy="2173304"/>
          </a:xfrm>
          <a:prstGeom prst="rect">
            <a:avLst/>
          </a:prstGeom>
        </p:spPr>
      </p:pic>
      <p:pic>
        <p:nvPicPr>
          <p:cNvPr id="40" name="Picture 39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301"/>
          <a:stretch/>
        </p:blipFill>
        <p:spPr>
          <a:xfrm>
            <a:off x="891836" y="4076938"/>
            <a:ext cx="2232364" cy="2146951"/>
          </a:xfrm>
          <a:prstGeom prst="rect">
            <a:avLst/>
          </a:prstGeom>
        </p:spPr>
      </p:pic>
      <p:pic>
        <p:nvPicPr>
          <p:cNvPr id="41" name="Picture 40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487"/>
          <a:stretch/>
        </p:blipFill>
        <p:spPr>
          <a:xfrm>
            <a:off x="3580328" y="4071825"/>
            <a:ext cx="2188012" cy="2197106"/>
          </a:xfrm>
          <a:prstGeom prst="rect">
            <a:avLst/>
          </a:prstGeom>
        </p:spPr>
      </p:pic>
      <p:pic>
        <p:nvPicPr>
          <p:cNvPr id="42" name="Picture 4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1836" y="6280892"/>
            <a:ext cx="2276344" cy="2285257"/>
          </a:xfrm>
          <a:prstGeom prst="rect">
            <a:avLst/>
          </a:prstGeom>
        </p:spPr>
      </p:pic>
      <p:pic>
        <p:nvPicPr>
          <p:cNvPr id="43" name="Picture 42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500"/>
          <a:stretch/>
        </p:blipFill>
        <p:spPr>
          <a:xfrm>
            <a:off x="3580328" y="6249151"/>
            <a:ext cx="2210872" cy="2171130"/>
          </a:xfrm>
          <a:prstGeom prst="rect">
            <a:avLst/>
          </a:prstGeom>
        </p:spPr>
      </p:pic>
      <p:pic>
        <p:nvPicPr>
          <p:cNvPr id="44" name="Picture 43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281"/>
          <a:stretch/>
        </p:blipFill>
        <p:spPr>
          <a:xfrm>
            <a:off x="891836" y="8666972"/>
            <a:ext cx="2308564" cy="22411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14939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4</TotalTime>
  <Words>108</Words>
  <Application>Microsoft Office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James Cook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ymaviswanathan Karnaneedi</dc:creator>
  <cp:lastModifiedBy>Shaymaviswanathan Karnaneedi</cp:lastModifiedBy>
  <cp:revision>13</cp:revision>
  <dcterms:created xsi:type="dcterms:W3CDTF">2020-11-09T03:01:03Z</dcterms:created>
  <dcterms:modified xsi:type="dcterms:W3CDTF">2020-11-18T09:05:17Z</dcterms:modified>
</cp:coreProperties>
</file>